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8" r:id="rId4"/>
    <p:sldId id="257" r:id="rId5"/>
    <p:sldId id="256" r:id="rId6"/>
    <p:sldId id="263" r:id="rId7"/>
    <p:sldId id="265" r:id="rId8"/>
    <p:sldId id="262" r:id="rId9"/>
    <p:sldId id="266" r:id="rId10"/>
    <p:sldId id="267" r:id="rId11"/>
    <p:sldId id="268" r:id="rId12"/>
    <p:sldId id="269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232" autoAdjust="0"/>
    <p:restoredTop sz="94660"/>
  </p:normalViewPr>
  <p:slideViewPr>
    <p:cSldViewPr snapToGrid="0">
      <p:cViewPr varScale="1">
        <p:scale>
          <a:sx n="91" d="100"/>
          <a:sy n="91" d="100"/>
        </p:scale>
        <p:origin x="86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018681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01886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28058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47798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68488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66901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91593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84287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58982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6562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60000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AFA11-0264-4BB4-B075-C12490C73632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DEF78E-0265-490B-A9D5-67C75766384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51041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png"/><Relationship Id="rId7" Type="http://schemas.openxmlformats.org/officeDocument/2006/relationships/image" Target="../media/image58.png"/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7.png"/><Relationship Id="rId5" Type="http://schemas.openxmlformats.org/officeDocument/2006/relationships/image" Target="../media/image56.png"/><Relationship Id="rId4" Type="http://schemas.openxmlformats.org/officeDocument/2006/relationships/image" Target="../media/image5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9.png"/><Relationship Id="rId5" Type="http://schemas.openxmlformats.org/officeDocument/2006/relationships/image" Target="../media/image68.png"/><Relationship Id="rId4" Type="http://schemas.openxmlformats.org/officeDocument/2006/relationships/image" Target="../media/image67.png"/><Relationship Id="rId9" Type="http://schemas.openxmlformats.org/officeDocument/2006/relationships/image" Target="../media/image7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3" Type="http://schemas.openxmlformats.org/officeDocument/2006/relationships/image" Target="../media/image24.png"/><Relationship Id="rId7" Type="http://schemas.openxmlformats.org/officeDocument/2006/relationships/image" Target="../media/image28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Relationship Id="rId9" Type="http://schemas.openxmlformats.org/officeDocument/2006/relationships/image" Target="../media/image3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7" Type="http://schemas.openxmlformats.org/officeDocument/2006/relationships/image" Target="../media/image52.png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1.png"/><Relationship Id="rId5" Type="http://schemas.openxmlformats.org/officeDocument/2006/relationships/image" Target="../media/image50.png"/><Relationship Id="rId4" Type="http://schemas.openxmlformats.org/officeDocument/2006/relationships/image" Target="../media/image4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208189" y="177675"/>
            <a:ext cx="209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Firm-AHN1X7F</a:t>
            </a:r>
            <a:endParaRPr lang="en-NZ" dirty="0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2"/>
          <a:srcRect l="13053" b="13826"/>
          <a:stretch/>
        </p:blipFill>
        <p:spPr>
          <a:xfrm>
            <a:off x="650630" y="896228"/>
            <a:ext cx="2484533" cy="2462434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3"/>
          <a:srcRect l="14425" b="13315"/>
          <a:stretch/>
        </p:blipFill>
        <p:spPr>
          <a:xfrm>
            <a:off x="703384" y="3747916"/>
            <a:ext cx="2445301" cy="2477038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2087514" y="1140223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5</a:t>
            </a:r>
            <a:endParaRPr lang="en-NZ" dirty="0"/>
          </a:p>
        </p:txBody>
      </p:sp>
      <p:sp>
        <p:nvSpPr>
          <p:cNvPr id="41" name="TextBox 40"/>
          <p:cNvSpPr txBox="1"/>
          <p:nvPr/>
        </p:nvSpPr>
        <p:spPr>
          <a:xfrm>
            <a:off x="2012397" y="3958251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67</a:t>
            </a:r>
            <a:endParaRPr lang="en-NZ" dirty="0"/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4"/>
          <a:srcRect l="3835"/>
          <a:stretch/>
        </p:blipFill>
        <p:spPr>
          <a:xfrm>
            <a:off x="3525715" y="828641"/>
            <a:ext cx="2747858" cy="2857500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5"/>
          <a:srcRect l="12893"/>
          <a:stretch/>
        </p:blipFill>
        <p:spPr>
          <a:xfrm>
            <a:off x="3784511" y="3679115"/>
            <a:ext cx="2489061" cy="2857500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4332401" y="3368938"/>
            <a:ext cx="1375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N1X7F</a:t>
            </a:r>
            <a:endParaRPr lang="en-NZ" sz="1050" dirty="0"/>
          </a:p>
        </p:txBody>
      </p:sp>
      <p:sp>
        <p:nvSpPr>
          <p:cNvPr id="46" name="TextBox 45"/>
          <p:cNvSpPr txBox="1"/>
          <p:nvPr/>
        </p:nvSpPr>
        <p:spPr>
          <a:xfrm>
            <a:off x="4332401" y="6221365"/>
            <a:ext cx="1375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N1X7F</a:t>
            </a:r>
            <a:endParaRPr lang="en-NZ" sz="105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2256859" y="1948337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2270484" y="4790834"/>
            <a:ext cx="2722220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Firmness (advanced selections and cultivars)</a:t>
            </a:r>
            <a:endParaRPr lang="en-NZ" sz="1100" dirty="0"/>
          </a:p>
        </p:txBody>
      </p:sp>
      <p:sp>
        <p:nvSpPr>
          <p:cNvPr id="49" name="TextBox 48"/>
          <p:cNvSpPr txBox="1"/>
          <p:nvPr/>
        </p:nvSpPr>
        <p:spPr>
          <a:xfrm>
            <a:off x="5649348" y="115381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50" name="TextBox 49"/>
          <p:cNvSpPr txBox="1"/>
          <p:nvPr/>
        </p:nvSpPr>
        <p:spPr>
          <a:xfrm>
            <a:off x="5649348" y="399785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-30803" y="1916785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1205309" y="3350095"/>
            <a:ext cx="1375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N1X7F</a:t>
            </a:r>
            <a:endParaRPr lang="en-NZ" sz="1050" dirty="0"/>
          </a:p>
        </p:txBody>
      </p:sp>
      <p:sp>
        <p:nvSpPr>
          <p:cNvPr id="55" name="TextBox 54"/>
          <p:cNvSpPr txBox="1"/>
          <p:nvPr/>
        </p:nvSpPr>
        <p:spPr>
          <a:xfrm>
            <a:off x="1205309" y="6203569"/>
            <a:ext cx="1375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N1X7F</a:t>
            </a:r>
            <a:endParaRPr lang="en-NZ" sz="1050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77843" y="4847935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6"/>
          <a:srcRect l="13399"/>
          <a:stretch/>
        </p:blipFill>
        <p:spPr>
          <a:xfrm>
            <a:off x="7051430" y="821615"/>
            <a:ext cx="2474615" cy="28575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7"/>
          <a:srcRect l="12800"/>
          <a:stretch/>
        </p:blipFill>
        <p:spPr>
          <a:xfrm>
            <a:off x="7051430" y="3663790"/>
            <a:ext cx="2491733" cy="285750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 rot="16200000">
            <a:off x="5863425" y="1933619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5877853" y="4776113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7585278" y="3361912"/>
            <a:ext cx="1375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N1X7F</a:t>
            </a:r>
            <a:endParaRPr lang="en-NZ" sz="1050" dirty="0"/>
          </a:p>
        </p:txBody>
      </p:sp>
      <p:sp>
        <p:nvSpPr>
          <p:cNvPr id="36" name="TextBox 35"/>
          <p:cNvSpPr txBox="1"/>
          <p:nvPr/>
        </p:nvSpPr>
        <p:spPr>
          <a:xfrm>
            <a:off x="7609447" y="6212207"/>
            <a:ext cx="1375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N1X7F</a:t>
            </a:r>
            <a:endParaRPr lang="en-NZ" sz="1050" dirty="0"/>
          </a:p>
        </p:txBody>
      </p:sp>
      <p:sp>
        <p:nvSpPr>
          <p:cNvPr id="38" name="TextBox 37"/>
          <p:cNvSpPr txBox="1"/>
          <p:nvPr/>
        </p:nvSpPr>
        <p:spPr>
          <a:xfrm>
            <a:off x="8409649" y="2858760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97</a:t>
            </a:r>
            <a:endParaRPr lang="en-NZ" dirty="0"/>
          </a:p>
        </p:txBody>
      </p:sp>
      <p:sp>
        <p:nvSpPr>
          <p:cNvPr id="40" name="TextBox 39"/>
          <p:cNvSpPr txBox="1"/>
          <p:nvPr/>
        </p:nvSpPr>
        <p:spPr>
          <a:xfrm>
            <a:off x="8409648" y="5697317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18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204812306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1672"/>
          <a:stretch/>
        </p:blipFill>
        <p:spPr>
          <a:xfrm>
            <a:off x="3771844" y="4132384"/>
            <a:ext cx="2857500" cy="252397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1817"/>
          <a:stretch/>
        </p:blipFill>
        <p:spPr>
          <a:xfrm>
            <a:off x="3771844" y="1151791"/>
            <a:ext cx="2857500" cy="25198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11364"/>
          <a:stretch/>
        </p:blipFill>
        <p:spPr>
          <a:xfrm>
            <a:off x="7236676" y="4123592"/>
            <a:ext cx="2857500" cy="253276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11817"/>
          <a:stretch/>
        </p:blipFill>
        <p:spPr>
          <a:xfrm>
            <a:off x="7236676" y="1151791"/>
            <a:ext cx="2857500" cy="251982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t="11672"/>
          <a:stretch/>
        </p:blipFill>
        <p:spPr>
          <a:xfrm>
            <a:off x="581564" y="4132384"/>
            <a:ext cx="2857500" cy="2523971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t="11817"/>
          <a:stretch/>
        </p:blipFill>
        <p:spPr>
          <a:xfrm>
            <a:off x="581564" y="1151791"/>
            <a:ext cx="2857500" cy="251982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08189" y="177675"/>
            <a:ext cx="2208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LAR1-AHKA3OQ</a:t>
            </a:r>
            <a:endParaRPr lang="en-NZ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32176" y="2018901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246602" y="5089106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6389391" y="2104367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6402601" y="5089105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540855" y="2058047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2540856" y="4969561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17" name="TextBox 16"/>
          <p:cNvSpPr txBox="1"/>
          <p:nvPr/>
        </p:nvSpPr>
        <p:spPr>
          <a:xfrm>
            <a:off x="1563223" y="3501734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KA3OQ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653728" y="3498622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KA3OQ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151593" y="3498622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KA3OQ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61887" y="6432445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KA3OQ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653728" y="6436426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KA3OQ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151593" y="6429348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KA3OQ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186051" y="1174823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&lt;0.0001</a:t>
            </a:r>
            <a:endParaRPr lang="en-NZ" dirty="0"/>
          </a:p>
        </p:txBody>
      </p:sp>
      <p:sp>
        <p:nvSpPr>
          <p:cNvPr id="24" name="TextBox 23"/>
          <p:cNvSpPr txBox="1"/>
          <p:nvPr/>
        </p:nvSpPr>
        <p:spPr>
          <a:xfrm>
            <a:off x="2240919" y="4132384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&lt;0.0001</a:t>
            </a:r>
            <a:endParaRPr lang="en-NZ" dirty="0"/>
          </a:p>
        </p:txBody>
      </p:sp>
      <p:sp>
        <p:nvSpPr>
          <p:cNvPr id="25" name="TextBox 24"/>
          <p:cNvSpPr txBox="1"/>
          <p:nvPr/>
        </p:nvSpPr>
        <p:spPr>
          <a:xfrm>
            <a:off x="5901354" y="1168561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6" name="TextBox 25"/>
          <p:cNvSpPr txBox="1"/>
          <p:nvPr/>
        </p:nvSpPr>
        <p:spPr>
          <a:xfrm>
            <a:off x="5929016" y="406527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7" name="TextBox 26"/>
          <p:cNvSpPr txBox="1"/>
          <p:nvPr/>
        </p:nvSpPr>
        <p:spPr>
          <a:xfrm>
            <a:off x="9478957" y="407721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9468254" y="1232825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4306333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1572"/>
          <a:stretch/>
        </p:blipFill>
        <p:spPr>
          <a:xfrm>
            <a:off x="391783" y="1204546"/>
            <a:ext cx="2857500" cy="252683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1694"/>
          <a:stretch/>
        </p:blipFill>
        <p:spPr>
          <a:xfrm>
            <a:off x="391783" y="4132385"/>
            <a:ext cx="2857500" cy="252334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11572"/>
          <a:stretch/>
        </p:blipFill>
        <p:spPr>
          <a:xfrm>
            <a:off x="3855952" y="1204546"/>
            <a:ext cx="2857500" cy="252683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11694"/>
          <a:stretch/>
        </p:blipFill>
        <p:spPr>
          <a:xfrm>
            <a:off x="3855952" y="4132385"/>
            <a:ext cx="2857500" cy="252334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t="11386"/>
          <a:stretch/>
        </p:blipFill>
        <p:spPr>
          <a:xfrm>
            <a:off x="7083890" y="4123591"/>
            <a:ext cx="2857500" cy="253213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t="11572"/>
          <a:stretch/>
        </p:blipFill>
        <p:spPr>
          <a:xfrm>
            <a:off x="7083890" y="1204546"/>
            <a:ext cx="2857500" cy="252683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08189" y="160091"/>
            <a:ext cx="5943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LAR1-AHLJ1UY, LG16 LAR1-AHI15II, LG16 LAR1-AH704YZ</a:t>
            </a:r>
            <a:endParaRPr lang="en-NZ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-14008" y="2098415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420" y="5088481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3461885" y="2098416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3476313" y="5088482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6706876" y="2098415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6721304" y="5088481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1299454" y="3485155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LJ1UY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299453" y="6409510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LJ1UY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792931" y="3485155"/>
            <a:ext cx="1207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I15II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792931" y="6409509"/>
            <a:ext cx="1207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I15II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075393" y="3485155"/>
            <a:ext cx="12987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704YZ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075392" y="6409508"/>
            <a:ext cx="12987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704YZ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001493" y="1174823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&lt;0.0001</a:t>
            </a:r>
            <a:endParaRPr lang="en-NZ" dirty="0"/>
          </a:p>
        </p:txBody>
      </p:sp>
      <p:sp>
        <p:nvSpPr>
          <p:cNvPr id="24" name="TextBox 23"/>
          <p:cNvSpPr txBox="1"/>
          <p:nvPr/>
        </p:nvSpPr>
        <p:spPr>
          <a:xfrm>
            <a:off x="2056361" y="4132384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&lt;0.0001</a:t>
            </a:r>
            <a:endParaRPr lang="en-NZ" dirty="0"/>
          </a:p>
        </p:txBody>
      </p:sp>
      <p:sp>
        <p:nvSpPr>
          <p:cNvPr id="25" name="TextBox 24"/>
          <p:cNvSpPr txBox="1"/>
          <p:nvPr/>
        </p:nvSpPr>
        <p:spPr>
          <a:xfrm>
            <a:off x="6113501" y="1167832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6" name="TextBox 25"/>
          <p:cNvSpPr txBox="1"/>
          <p:nvPr/>
        </p:nvSpPr>
        <p:spPr>
          <a:xfrm>
            <a:off x="6168369" y="4125393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7" name="TextBox 26"/>
          <p:cNvSpPr txBox="1"/>
          <p:nvPr/>
        </p:nvSpPr>
        <p:spPr>
          <a:xfrm>
            <a:off x="8683075" y="1204545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40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8737943" y="416210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84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53140285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1608"/>
          <a:stretch/>
        </p:blipFill>
        <p:spPr>
          <a:xfrm>
            <a:off x="3067464" y="1283677"/>
            <a:ext cx="2857500" cy="252579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1675"/>
          <a:stretch/>
        </p:blipFill>
        <p:spPr>
          <a:xfrm>
            <a:off x="3067464" y="4185138"/>
            <a:ext cx="2857500" cy="252389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11300"/>
          <a:stretch/>
        </p:blipFill>
        <p:spPr>
          <a:xfrm>
            <a:off x="5924964" y="1274884"/>
            <a:ext cx="2857500" cy="253458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11675"/>
          <a:stretch/>
        </p:blipFill>
        <p:spPr>
          <a:xfrm>
            <a:off x="5924964" y="4185138"/>
            <a:ext cx="2857500" cy="252389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t="11675"/>
          <a:stretch/>
        </p:blipFill>
        <p:spPr>
          <a:xfrm>
            <a:off x="8933426" y="1327638"/>
            <a:ext cx="2857500" cy="252389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t="11675"/>
          <a:stretch/>
        </p:blipFill>
        <p:spPr>
          <a:xfrm>
            <a:off x="8933426" y="4185138"/>
            <a:ext cx="2857500" cy="252389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08189" y="177675"/>
            <a:ext cx="8405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LAR1-AHHS7CA, LG16 LAR1-AH6R6SR, LG16 LAR1-AHBKGG8, LG16 LAR1-AHMSZ06</a:t>
            </a:r>
            <a:endParaRPr lang="en-NZ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/>
          <a:srcRect t="11916"/>
          <a:stretch/>
        </p:blipFill>
        <p:spPr>
          <a:xfrm>
            <a:off x="209964" y="1292468"/>
            <a:ext cx="2857500" cy="251700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9"/>
          <a:srcRect t="11503"/>
          <a:stretch/>
        </p:blipFill>
        <p:spPr>
          <a:xfrm>
            <a:off x="209964" y="4211514"/>
            <a:ext cx="2857500" cy="2528785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 rot="16200000">
            <a:off x="-172268" y="2204183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-157840" y="5194249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2685232" y="2198791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699660" y="5188857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5542733" y="2198791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5557161" y="5188857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8607604" y="2198792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8622032" y="5188858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1180506" y="3599916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HS7C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180506" y="6494079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HS7C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979809" y="3599916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6R6SR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979809" y="6494078"/>
            <a:ext cx="13083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6R6SR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837309" y="3599915"/>
            <a:ext cx="1343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BKGG8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837309" y="6494077"/>
            <a:ext cx="13436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BKGG8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9845448" y="3598010"/>
            <a:ext cx="13388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MSZ06</a:t>
            </a:r>
            <a:endParaRPr lang="en-NZ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9845448" y="6494076"/>
            <a:ext cx="13388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MSZ06</a:t>
            </a:r>
            <a:endParaRPr lang="en-NZ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1766159" y="1354713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78</a:t>
            </a:r>
            <a:endParaRPr lang="en-NZ" dirty="0"/>
          </a:p>
        </p:txBody>
      </p:sp>
      <p:sp>
        <p:nvSpPr>
          <p:cNvPr id="32" name="TextBox 31"/>
          <p:cNvSpPr txBox="1"/>
          <p:nvPr/>
        </p:nvSpPr>
        <p:spPr>
          <a:xfrm>
            <a:off x="1821027" y="4312274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87</a:t>
            </a:r>
            <a:endParaRPr lang="en-NZ" dirty="0"/>
          </a:p>
        </p:txBody>
      </p:sp>
      <p:sp>
        <p:nvSpPr>
          <p:cNvPr id="33" name="TextBox 32"/>
          <p:cNvSpPr txBox="1"/>
          <p:nvPr/>
        </p:nvSpPr>
        <p:spPr>
          <a:xfrm>
            <a:off x="4717561" y="1302619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57</a:t>
            </a:r>
            <a:endParaRPr lang="en-NZ" dirty="0"/>
          </a:p>
        </p:txBody>
      </p:sp>
      <p:sp>
        <p:nvSpPr>
          <p:cNvPr id="34" name="TextBox 33"/>
          <p:cNvSpPr txBox="1"/>
          <p:nvPr/>
        </p:nvSpPr>
        <p:spPr>
          <a:xfrm>
            <a:off x="5210310" y="429480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5" name="TextBox 34"/>
          <p:cNvSpPr txBox="1"/>
          <p:nvPr/>
        </p:nvSpPr>
        <p:spPr>
          <a:xfrm>
            <a:off x="7598748" y="1354713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57</a:t>
            </a:r>
            <a:endParaRPr lang="en-NZ" dirty="0"/>
          </a:p>
        </p:txBody>
      </p:sp>
      <p:sp>
        <p:nvSpPr>
          <p:cNvPr id="36" name="TextBox 35"/>
          <p:cNvSpPr txBox="1"/>
          <p:nvPr/>
        </p:nvSpPr>
        <p:spPr>
          <a:xfrm>
            <a:off x="8091497" y="43469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7" name="TextBox 36"/>
          <p:cNvSpPr txBox="1"/>
          <p:nvPr/>
        </p:nvSpPr>
        <p:spPr>
          <a:xfrm>
            <a:off x="11184276" y="437643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8" name="TextBox 37"/>
          <p:cNvSpPr txBox="1"/>
          <p:nvPr/>
        </p:nvSpPr>
        <p:spPr>
          <a:xfrm>
            <a:off x="11184276" y="140099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1256023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/>
          <a:srcRect l="11893"/>
          <a:stretch/>
        </p:blipFill>
        <p:spPr>
          <a:xfrm>
            <a:off x="4451070" y="858863"/>
            <a:ext cx="2517668" cy="28575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/>
          <a:srcRect l="14047"/>
          <a:stretch/>
        </p:blipFill>
        <p:spPr>
          <a:xfrm>
            <a:off x="4512616" y="3716363"/>
            <a:ext cx="2456122" cy="28575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981980" y="3403404"/>
            <a:ext cx="14558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PAWDN</a:t>
            </a:r>
            <a:endParaRPr lang="en-NZ" sz="1050" dirty="0"/>
          </a:p>
        </p:txBody>
      </p:sp>
      <p:sp>
        <p:nvSpPr>
          <p:cNvPr id="19" name="TextBox 18"/>
          <p:cNvSpPr txBox="1"/>
          <p:nvPr/>
        </p:nvSpPr>
        <p:spPr>
          <a:xfrm>
            <a:off x="4981980" y="6294351"/>
            <a:ext cx="14558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PAWDN</a:t>
            </a:r>
            <a:endParaRPr lang="en-NZ" sz="105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004078" y="2102793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2997973" y="4963837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31" name="TextBox 30"/>
          <p:cNvSpPr txBox="1"/>
          <p:nvPr/>
        </p:nvSpPr>
        <p:spPr>
          <a:xfrm>
            <a:off x="6360393" y="284940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5" name="TextBox 34"/>
          <p:cNvSpPr txBox="1"/>
          <p:nvPr/>
        </p:nvSpPr>
        <p:spPr>
          <a:xfrm>
            <a:off x="4735849" y="403632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208189" y="177675"/>
            <a:ext cx="20448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0 PG-AHPAWDN</a:t>
            </a:r>
            <a:endParaRPr lang="en-NZ" dirty="0"/>
          </a:p>
        </p:txBody>
      </p:sp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4"/>
          <a:srcRect l="13225" b="13999"/>
          <a:stretch/>
        </p:blipFill>
        <p:spPr>
          <a:xfrm>
            <a:off x="1099038" y="997895"/>
            <a:ext cx="2479602" cy="2457482"/>
          </a:xfrm>
          <a:prstGeom prst="rect">
            <a:avLst/>
          </a:prstGeom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5"/>
          <a:srcRect l="13228" b="13117"/>
          <a:stretch/>
        </p:blipFill>
        <p:spPr>
          <a:xfrm>
            <a:off x="1116622" y="3856573"/>
            <a:ext cx="2479515" cy="2482681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2455780" y="2914155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32</a:t>
            </a:r>
            <a:endParaRPr lang="en-NZ" dirty="0"/>
          </a:p>
        </p:txBody>
      </p:sp>
      <p:sp>
        <p:nvSpPr>
          <p:cNvPr id="46" name="TextBox 45"/>
          <p:cNvSpPr txBox="1"/>
          <p:nvPr/>
        </p:nvSpPr>
        <p:spPr>
          <a:xfrm>
            <a:off x="2455780" y="5816871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58</a:t>
            </a:r>
            <a:endParaRPr lang="en-NZ" dirty="0"/>
          </a:p>
        </p:txBody>
      </p:sp>
      <p:sp>
        <p:nvSpPr>
          <p:cNvPr id="48" name="TextBox 47"/>
          <p:cNvSpPr txBox="1"/>
          <p:nvPr/>
        </p:nvSpPr>
        <p:spPr>
          <a:xfrm>
            <a:off x="1638480" y="3440505"/>
            <a:ext cx="14558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PAWDN</a:t>
            </a:r>
            <a:endParaRPr lang="en-NZ" sz="1050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381210" y="2084637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1628455" y="6319947"/>
            <a:ext cx="14558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PAWDN</a:t>
            </a:r>
            <a:endParaRPr lang="en-NZ" sz="1050" dirty="0"/>
          </a:p>
        </p:txBody>
      </p:sp>
      <p:sp>
        <p:nvSpPr>
          <p:cNvPr id="52" name="TextBox 51"/>
          <p:cNvSpPr txBox="1"/>
          <p:nvPr/>
        </p:nvSpPr>
        <p:spPr>
          <a:xfrm rot="16200000">
            <a:off x="395637" y="4997367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6"/>
          <a:srcRect l="13447"/>
          <a:stretch/>
        </p:blipFill>
        <p:spPr>
          <a:xfrm>
            <a:off x="7877279" y="858863"/>
            <a:ext cx="2473245" cy="28575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99648" y="3721252"/>
            <a:ext cx="2857500" cy="2857500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 rot="16200000">
            <a:off x="6716000" y="2034621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6730427" y="4991639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8388247" y="3394612"/>
            <a:ext cx="14558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PAWDN</a:t>
            </a:r>
            <a:endParaRPr lang="en-NZ" sz="1050" dirty="0"/>
          </a:p>
        </p:txBody>
      </p:sp>
      <p:sp>
        <p:nvSpPr>
          <p:cNvPr id="51" name="TextBox 50"/>
          <p:cNvSpPr txBox="1"/>
          <p:nvPr/>
        </p:nvSpPr>
        <p:spPr>
          <a:xfrm>
            <a:off x="8385977" y="6269931"/>
            <a:ext cx="14558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PAWDN</a:t>
            </a:r>
            <a:endParaRPr lang="en-NZ" sz="1050" dirty="0"/>
          </a:p>
        </p:txBody>
      </p:sp>
      <p:sp>
        <p:nvSpPr>
          <p:cNvPr id="53" name="TextBox 52"/>
          <p:cNvSpPr txBox="1"/>
          <p:nvPr/>
        </p:nvSpPr>
        <p:spPr>
          <a:xfrm>
            <a:off x="9720888" y="2844344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54" name="TextBox 53"/>
          <p:cNvSpPr txBox="1"/>
          <p:nvPr/>
        </p:nvSpPr>
        <p:spPr>
          <a:xfrm>
            <a:off x="8100513" y="4027535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136709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b="13393"/>
          <a:stretch/>
        </p:blipFill>
        <p:spPr>
          <a:xfrm>
            <a:off x="518357" y="685493"/>
            <a:ext cx="2857500" cy="247480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15316" b="13140"/>
          <a:stretch/>
        </p:blipFill>
        <p:spPr>
          <a:xfrm>
            <a:off x="954505" y="3694206"/>
            <a:ext cx="2419850" cy="2482005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111068" y="920277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&lt;0.0001</a:t>
            </a:r>
            <a:endParaRPr lang="en-NZ" dirty="0"/>
          </a:p>
        </p:txBody>
      </p:sp>
      <p:sp>
        <p:nvSpPr>
          <p:cNvPr id="25" name="TextBox 24"/>
          <p:cNvSpPr txBox="1"/>
          <p:nvPr/>
        </p:nvSpPr>
        <p:spPr>
          <a:xfrm>
            <a:off x="2111068" y="3929848"/>
            <a:ext cx="1061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&lt;0.0001</a:t>
            </a:r>
            <a:endParaRPr lang="en-NZ" dirty="0"/>
          </a:p>
        </p:txBody>
      </p:sp>
      <p:sp>
        <p:nvSpPr>
          <p:cNvPr id="14" name="TextBox 13"/>
          <p:cNvSpPr txBox="1"/>
          <p:nvPr/>
        </p:nvSpPr>
        <p:spPr>
          <a:xfrm>
            <a:off x="208189" y="177675"/>
            <a:ext cx="19666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0 PG-AHMSZ07</a:t>
            </a:r>
            <a:endParaRPr lang="en-NZ" dirty="0"/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/>
          <a:srcRect l="12301"/>
          <a:stretch/>
        </p:blipFill>
        <p:spPr>
          <a:xfrm>
            <a:off x="7742670" y="624030"/>
            <a:ext cx="2505985" cy="28575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5"/>
          <a:srcRect l="12816"/>
          <a:stretch/>
        </p:blipFill>
        <p:spPr>
          <a:xfrm>
            <a:off x="7758712" y="3637715"/>
            <a:ext cx="2491281" cy="28575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16200000">
            <a:off x="6585076" y="1887727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6595217" y="4842051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8356008" y="3142853"/>
            <a:ext cx="1396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MSZ07</a:t>
            </a:r>
            <a:endParaRPr lang="en-NZ" sz="1050" dirty="0"/>
          </a:p>
        </p:txBody>
      </p:sp>
      <p:sp>
        <p:nvSpPr>
          <p:cNvPr id="20" name="TextBox 19"/>
          <p:cNvSpPr txBox="1"/>
          <p:nvPr/>
        </p:nvSpPr>
        <p:spPr>
          <a:xfrm>
            <a:off x="8297394" y="6141259"/>
            <a:ext cx="1396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MSZ07</a:t>
            </a:r>
            <a:endParaRPr lang="en-NZ" sz="1050" dirty="0"/>
          </a:p>
        </p:txBody>
      </p:sp>
      <p:sp>
        <p:nvSpPr>
          <p:cNvPr id="24" name="TextBox 23"/>
          <p:cNvSpPr txBox="1"/>
          <p:nvPr/>
        </p:nvSpPr>
        <p:spPr>
          <a:xfrm>
            <a:off x="7977545" y="2633467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09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9656208" y="397219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7" name="TextBox 36"/>
          <p:cNvSpPr txBox="1"/>
          <p:nvPr/>
        </p:nvSpPr>
        <p:spPr>
          <a:xfrm rot="16200000">
            <a:off x="139719" y="1845377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1351852" y="3108901"/>
            <a:ext cx="1396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MSZ07</a:t>
            </a:r>
            <a:endParaRPr lang="en-NZ" sz="105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154147" y="4885237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1450120" y="6098908"/>
            <a:ext cx="1396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MSZ07</a:t>
            </a:r>
            <a:endParaRPr lang="en-NZ" sz="1050" dirty="0"/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6"/>
          <a:srcRect l="13711"/>
          <a:stretch/>
        </p:blipFill>
        <p:spPr>
          <a:xfrm>
            <a:off x="4400246" y="600732"/>
            <a:ext cx="2465711" cy="2857500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7"/>
          <a:srcRect l="13430"/>
          <a:stretch/>
        </p:blipFill>
        <p:spPr>
          <a:xfrm>
            <a:off x="4400247" y="3616739"/>
            <a:ext cx="2473730" cy="2857500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4916640" y="3120954"/>
            <a:ext cx="1396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MSZ07</a:t>
            </a:r>
            <a:endParaRPr lang="en-NZ" sz="1050" dirty="0"/>
          </a:p>
        </p:txBody>
      </p:sp>
      <p:sp>
        <p:nvSpPr>
          <p:cNvPr id="43" name="TextBox 42"/>
          <p:cNvSpPr txBox="1"/>
          <p:nvPr/>
        </p:nvSpPr>
        <p:spPr>
          <a:xfrm>
            <a:off x="4964331" y="6116857"/>
            <a:ext cx="13965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50" dirty="0" smtClean="0"/>
              <a:t>SNP marker AHMSZ07</a:t>
            </a:r>
            <a:endParaRPr lang="en-NZ" sz="105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2814686" y="1843558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2813083" y="4825344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46" name="TextBox 45"/>
          <p:cNvSpPr txBox="1"/>
          <p:nvPr/>
        </p:nvSpPr>
        <p:spPr>
          <a:xfrm>
            <a:off x="6243476" y="93579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47" name="TextBox 46"/>
          <p:cNvSpPr txBox="1"/>
          <p:nvPr/>
        </p:nvSpPr>
        <p:spPr>
          <a:xfrm>
            <a:off x="5829741" y="3947797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7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4149170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95651" y="784400"/>
            <a:ext cx="2857500" cy="28575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5651" y="3870500"/>
            <a:ext cx="2857500" cy="28575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7637836" y="11273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12" name="TextBox 11"/>
          <p:cNvSpPr txBox="1"/>
          <p:nvPr/>
        </p:nvSpPr>
        <p:spPr>
          <a:xfrm>
            <a:off x="7637836" y="40991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" name="TextBox 1"/>
          <p:cNvSpPr txBox="1"/>
          <p:nvPr/>
        </p:nvSpPr>
        <p:spPr>
          <a:xfrm>
            <a:off x="208189" y="177675"/>
            <a:ext cx="2156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5 ACS1-AHZAHRE</a:t>
            </a:r>
            <a:endParaRPr lang="en-NZ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30494" y="784400"/>
            <a:ext cx="2857500" cy="28575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30494" y="3870500"/>
            <a:ext cx="2857500" cy="28575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354569" y="11273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17" name="TextBox 16"/>
          <p:cNvSpPr txBox="1"/>
          <p:nvPr/>
        </p:nvSpPr>
        <p:spPr>
          <a:xfrm>
            <a:off x="4453629" y="40991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349329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29343" y="807969"/>
            <a:ext cx="2857500" cy="28575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29343" y="3894069"/>
            <a:ext cx="2857500" cy="28575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381732" y="104418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14" name="TextBox 13"/>
          <p:cNvSpPr txBox="1"/>
          <p:nvPr/>
        </p:nvSpPr>
        <p:spPr>
          <a:xfrm>
            <a:off x="9308663" y="416076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4308" y="3935941"/>
            <a:ext cx="2857500" cy="28575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5646" y="807969"/>
            <a:ext cx="2857500" cy="28575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 rot="16200000">
            <a:off x="335855" y="1843645"/>
            <a:ext cx="136543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400" dirty="0" smtClean="0"/>
              <a:t>Firmness (BLUP)</a:t>
            </a:r>
            <a:endParaRPr lang="en-NZ" sz="14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18819" y="4957362"/>
            <a:ext cx="1402307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400" dirty="0" smtClean="0"/>
              <a:t>Crispness (BLUP)</a:t>
            </a:r>
            <a:endParaRPr lang="en-NZ" sz="1400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6"/>
          <a:srcRect l="14386" t="11286" r="5667" b="11286"/>
          <a:stretch/>
        </p:blipFill>
        <p:spPr>
          <a:xfrm>
            <a:off x="1145443" y="1016173"/>
            <a:ext cx="2284493" cy="2212522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7"/>
          <a:srcRect l="13334" t="10428" r="5238" b="10428"/>
          <a:stretch/>
        </p:blipFill>
        <p:spPr>
          <a:xfrm>
            <a:off x="1135771" y="4096110"/>
            <a:ext cx="2351888" cy="228587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653420" y="1062717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400" dirty="0" smtClean="0"/>
              <a:t>P=0.096</a:t>
            </a:r>
            <a:endParaRPr lang="en-NZ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2658868" y="4232606"/>
            <a:ext cx="777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400" dirty="0" smtClean="0"/>
              <a:t>P=0.065</a:t>
            </a:r>
            <a:endParaRPr lang="en-NZ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208189" y="177675"/>
            <a:ext cx="20630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5 Firm-AHQJUJV</a:t>
            </a:r>
            <a:endParaRPr lang="en-NZ" dirty="0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02943" y="807969"/>
            <a:ext cx="2857500" cy="28575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002943" y="3894069"/>
            <a:ext cx="2857500" cy="285750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6255332" y="104418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6182263" y="4160769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7421143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208189" y="177675"/>
            <a:ext cx="2188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Firm-AHS1QWB</a:t>
            </a:r>
            <a:endParaRPr lang="en-NZ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03614" y="653734"/>
            <a:ext cx="2857500" cy="28575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/>
          <a:srcRect l="13505"/>
          <a:stretch/>
        </p:blipFill>
        <p:spPr>
          <a:xfrm>
            <a:off x="6707112" y="3674535"/>
            <a:ext cx="2471585" cy="28575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7233952" y="6209048"/>
            <a:ext cx="1375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S1QWB</a:t>
            </a:r>
            <a:endParaRPr lang="en-NZ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7233952" y="3200607"/>
            <a:ext cx="1375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S1QWB</a:t>
            </a:r>
            <a:endParaRPr lang="en-NZ" sz="10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5512560" y="1878816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5522848" y="4789577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27" name="TextBox 26"/>
          <p:cNvSpPr txBox="1"/>
          <p:nvPr/>
        </p:nvSpPr>
        <p:spPr>
          <a:xfrm>
            <a:off x="6909288" y="2667974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55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6909287" y="564898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23</a:t>
            </a:r>
            <a:endParaRPr lang="en-NZ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41522" y="644942"/>
            <a:ext cx="2857500" cy="28575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41522" y="3674535"/>
            <a:ext cx="2857500" cy="2857500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3083745" y="6209048"/>
            <a:ext cx="1375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S1QWB</a:t>
            </a:r>
            <a:endParaRPr lang="en-NZ" sz="1000" dirty="0"/>
          </a:p>
        </p:txBody>
      </p:sp>
      <p:sp>
        <p:nvSpPr>
          <p:cNvPr id="31" name="TextBox 30"/>
          <p:cNvSpPr txBox="1"/>
          <p:nvPr/>
        </p:nvSpPr>
        <p:spPr>
          <a:xfrm>
            <a:off x="3083745" y="3200606"/>
            <a:ext cx="13756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S1QWB</a:t>
            </a:r>
            <a:endParaRPr lang="en-NZ" sz="1000" dirty="0"/>
          </a:p>
        </p:txBody>
      </p:sp>
      <p:sp>
        <p:nvSpPr>
          <p:cNvPr id="32" name="TextBox 31"/>
          <p:cNvSpPr txBox="1"/>
          <p:nvPr/>
        </p:nvSpPr>
        <p:spPr>
          <a:xfrm rot="16200000">
            <a:off x="1086373" y="1886509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1086374" y="4968730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34" name="TextBox 33"/>
          <p:cNvSpPr txBox="1"/>
          <p:nvPr/>
        </p:nvSpPr>
        <p:spPr>
          <a:xfrm>
            <a:off x="4459443" y="100879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5" name="TextBox 34"/>
          <p:cNvSpPr txBox="1"/>
          <p:nvPr/>
        </p:nvSpPr>
        <p:spPr>
          <a:xfrm>
            <a:off x="4436086" y="406197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28053561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8642" y="592839"/>
            <a:ext cx="2857500" cy="28575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7530" y="3328492"/>
            <a:ext cx="2857500" cy="28575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7530" y="597877"/>
            <a:ext cx="2857500" cy="28575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992057" y="6059107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ZAHRF</a:t>
            </a:r>
            <a:endParaRPr lang="en-NZ" sz="10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619035" y="1787186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21143" y="3323454"/>
            <a:ext cx="2857500" cy="28575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 rot="16200000">
            <a:off x="639218" y="4544754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5099393" y="6054069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ZAHRF</a:t>
            </a:r>
            <a:endParaRPr lang="en-NZ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1882585" y="3209156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ZAHRF</a:t>
            </a:r>
            <a:endParaRPr lang="en-NZ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4989921" y="3204118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ZAHRF</a:t>
            </a:r>
            <a:endParaRPr lang="en-NZ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2713437" y="3715103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46</a:t>
            </a:r>
            <a:endParaRPr lang="en-NZ" dirty="0"/>
          </a:p>
        </p:txBody>
      </p:sp>
      <p:sp>
        <p:nvSpPr>
          <p:cNvPr id="23" name="TextBox 22"/>
          <p:cNvSpPr txBox="1"/>
          <p:nvPr/>
        </p:nvSpPr>
        <p:spPr>
          <a:xfrm>
            <a:off x="2732145" y="943108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28</a:t>
            </a:r>
            <a:endParaRPr lang="en-NZ" dirty="0"/>
          </a:p>
        </p:txBody>
      </p:sp>
      <p:sp>
        <p:nvSpPr>
          <p:cNvPr id="24" name="TextBox 23"/>
          <p:cNvSpPr txBox="1"/>
          <p:nvPr/>
        </p:nvSpPr>
        <p:spPr>
          <a:xfrm>
            <a:off x="6438857" y="104478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5" name="TextBox 24"/>
          <p:cNvSpPr txBox="1"/>
          <p:nvPr/>
        </p:nvSpPr>
        <p:spPr>
          <a:xfrm>
            <a:off x="6351181" y="3775395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-302" y="55930"/>
            <a:ext cx="20953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</a:t>
            </a:r>
            <a:r>
              <a:rPr lang="en-NZ" dirty="0"/>
              <a:t>Firm-AHZAHRF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3150292" y="1789841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3154183" y="4658648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59251" y="592839"/>
            <a:ext cx="2857500" cy="2857500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 rot="16200000">
            <a:off x="6909970" y="1724649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59251" y="3323454"/>
            <a:ext cx="2857500" cy="2857500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 rot="16200000">
            <a:off x="6930154" y="4482217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8723344" y="6054069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ZAHRF</a:t>
            </a:r>
            <a:endParaRPr lang="en-NZ" sz="1000" dirty="0"/>
          </a:p>
        </p:txBody>
      </p:sp>
      <p:sp>
        <p:nvSpPr>
          <p:cNvPr id="36" name="TextBox 35"/>
          <p:cNvSpPr txBox="1"/>
          <p:nvPr/>
        </p:nvSpPr>
        <p:spPr>
          <a:xfrm>
            <a:off x="8613872" y="3204118"/>
            <a:ext cx="1321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ZAHRF</a:t>
            </a:r>
            <a:endParaRPr lang="en-NZ" sz="1000" dirty="0"/>
          </a:p>
        </p:txBody>
      </p:sp>
      <p:sp>
        <p:nvSpPr>
          <p:cNvPr id="37" name="TextBox 36"/>
          <p:cNvSpPr txBox="1"/>
          <p:nvPr/>
        </p:nvSpPr>
        <p:spPr>
          <a:xfrm>
            <a:off x="9772811" y="104478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8" name="TextBox 37"/>
          <p:cNvSpPr txBox="1"/>
          <p:nvPr/>
        </p:nvSpPr>
        <p:spPr>
          <a:xfrm>
            <a:off x="9685135" y="3775395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27753816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/>
          <a:srcRect b="13758"/>
          <a:stretch/>
        </p:blipFill>
        <p:spPr>
          <a:xfrm>
            <a:off x="1119864" y="832748"/>
            <a:ext cx="2857500" cy="2464367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9864" y="3690248"/>
            <a:ext cx="2857500" cy="28575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099555" y="6219010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UAO2J</a:t>
            </a:r>
            <a:endParaRPr lang="en-NZ" sz="10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726533" y="2029605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742131" y="4983931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3342175" y="1091828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7" name="TextBox 26"/>
          <p:cNvSpPr txBox="1"/>
          <p:nvPr/>
        </p:nvSpPr>
        <p:spPr>
          <a:xfrm>
            <a:off x="2821981" y="5721249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53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208189" y="177675"/>
            <a:ext cx="20969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Firm-AHUAO2J</a:t>
            </a:r>
            <a:endParaRPr lang="en-NZ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56441" y="733332"/>
            <a:ext cx="2857500" cy="28575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6441" y="3690248"/>
            <a:ext cx="2857500" cy="285750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5740681" y="6214463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UAO2J</a:t>
            </a:r>
            <a:endParaRPr lang="en-NZ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5717989" y="3292568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UAO2J</a:t>
            </a:r>
            <a:endParaRPr lang="en-NZ" sz="1000" dirty="0"/>
          </a:p>
        </p:txBody>
      </p:sp>
      <p:sp>
        <p:nvSpPr>
          <p:cNvPr id="33" name="TextBox 32"/>
          <p:cNvSpPr txBox="1"/>
          <p:nvPr/>
        </p:nvSpPr>
        <p:spPr>
          <a:xfrm rot="16200000">
            <a:off x="3479501" y="1748694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3479502" y="4914548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35" name="TextBox 34"/>
          <p:cNvSpPr txBox="1"/>
          <p:nvPr/>
        </p:nvSpPr>
        <p:spPr>
          <a:xfrm>
            <a:off x="6870158" y="109718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6" name="TextBox 35"/>
          <p:cNvSpPr txBox="1"/>
          <p:nvPr/>
        </p:nvSpPr>
        <p:spPr>
          <a:xfrm>
            <a:off x="6870158" y="4025191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37" name="TextBox 36"/>
          <p:cNvSpPr txBox="1"/>
          <p:nvPr/>
        </p:nvSpPr>
        <p:spPr>
          <a:xfrm>
            <a:off x="2099555" y="3285862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UAO2J</a:t>
            </a:r>
            <a:endParaRPr lang="en-NZ" sz="1000" dirty="0"/>
          </a:p>
        </p:txBody>
      </p:sp>
      <p:pic>
        <p:nvPicPr>
          <p:cNvPr id="38" name="Picture 3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107145" y="733332"/>
            <a:ext cx="2857500" cy="2857500"/>
          </a:xfrm>
          <a:prstGeom prst="rect">
            <a:avLst/>
          </a:prstGeom>
        </p:spPr>
      </p:pic>
      <p:pic>
        <p:nvPicPr>
          <p:cNvPr id="39" name="Picture 3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07145" y="3669740"/>
            <a:ext cx="2857500" cy="2857500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9107603" y="6213404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UAO2J</a:t>
            </a:r>
            <a:endParaRPr lang="en-NZ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9105624" y="3280204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AHUAO2J</a:t>
            </a:r>
            <a:endParaRPr lang="en-NZ" sz="1000" dirty="0"/>
          </a:p>
        </p:txBody>
      </p:sp>
      <p:sp>
        <p:nvSpPr>
          <p:cNvPr id="42" name="TextBox 41"/>
          <p:cNvSpPr txBox="1"/>
          <p:nvPr/>
        </p:nvSpPr>
        <p:spPr>
          <a:xfrm rot="16200000">
            <a:off x="7283661" y="1958415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7300016" y="4881038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10297749" y="113528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45" name="TextBox 44"/>
          <p:cNvSpPr txBox="1"/>
          <p:nvPr/>
        </p:nvSpPr>
        <p:spPr>
          <a:xfrm>
            <a:off x="10339211" y="4018023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9057155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1518"/>
          <a:stretch/>
        </p:blipFill>
        <p:spPr>
          <a:xfrm>
            <a:off x="621876" y="1169376"/>
            <a:ext cx="2857500" cy="25283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1826"/>
          <a:stretch/>
        </p:blipFill>
        <p:spPr>
          <a:xfrm>
            <a:off x="4131625" y="1165303"/>
            <a:ext cx="2857500" cy="251958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11518"/>
          <a:stretch/>
        </p:blipFill>
        <p:spPr>
          <a:xfrm>
            <a:off x="4131625" y="4014936"/>
            <a:ext cx="2857500" cy="252837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11518"/>
          <a:stretch/>
        </p:blipFill>
        <p:spPr>
          <a:xfrm>
            <a:off x="7641374" y="4026877"/>
            <a:ext cx="2857500" cy="252837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t="11517"/>
          <a:stretch/>
        </p:blipFill>
        <p:spPr>
          <a:xfrm>
            <a:off x="7641374" y="1182492"/>
            <a:ext cx="2857500" cy="252837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t="11518"/>
          <a:stretch/>
        </p:blipFill>
        <p:spPr>
          <a:xfrm>
            <a:off x="621876" y="4026876"/>
            <a:ext cx="2857500" cy="252837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208189" y="177675"/>
            <a:ext cx="2147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LG16 LAR1-AHFBAZU</a:t>
            </a:r>
            <a:endParaRPr lang="en-NZ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889715" y="2071316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2889716" y="4983756"/>
            <a:ext cx="2749471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100" dirty="0" smtClean="0"/>
              <a:t>Crispness (advanced selections and cultivars)</a:t>
            </a:r>
            <a:endParaRPr lang="en-NZ" sz="11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232174" y="2112500"/>
            <a:ext cx="122649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BLUP)</a:t>
            </a:r>
            <a:endParaRPr lang="en-NZ" sz="1200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245782" y="4955573"/>
            <a:ext cx="11976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BLUP)</a:t>
            </a:r>
            <a:endParaRPr lang="en-NZ" sz="12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6757095" y="2150300"/>
            <a:ext cx="204556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Crispness (Validation families)</a:t>
            </a:r>
            <a:endParaRPr lang="en-NZ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6773450" y="5072923"/>
            <a:ext cx="201670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sz="1200" dirty="0" smtClean="0"/>
              <a:t>Firmness (Validation families)</a:t>
            </a:r>
            <a:endParaRPr lang="en-NZ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1563223" y="3501734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FBAZU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407923" y="3513627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FBAZU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898174" y="3485740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FBAZU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63223" y="6378126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FBAZU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407923" y="6391241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FBAZU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898174" y="6391241"/>
            <a:ext cx="13244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000" dirty="0" smtClean="0"/>
              <a:t>SNP marker </a:t>
            </a:r>
            <a:r>
              <a:rPr lang="en-NZ" sz="1000" dirty="0"/>
              <a:t>AHFBAZU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314102" y="1246007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26</a:t>
            </a:r>
            <a:endParaRPr lang="en-NZ" dirty="0"/>
          </a:p>
        </p:txBody>
      </p:sp>
      <p:sp>
        <p:nvSpPr>
          <p:cNvPr id="24" name="TextBox 23"/>
          <p:cNvSpPr txBox="1"/>
          <p:nvPr/>
        </p:nvSpPr>
        <p:spPr>
          <a:xfrm>
            <a:off x="2305201" y="4014936"/>
            <a:ext cx="944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P=0.040</a:t>
            </a:r>
            <a:endParaRPr lang="en-NZ" dirty="0"/>
          </a:p>
        </p:txBody>
      </p:sp>
      <p:sp>
        <p:nvSpPr>
          <p:cNvPr id="25" name="TextBox 24"/>
          <p:cNvSpPr txBox="1"/>
          <p:nvPr/>
        </p:nvSpPr>
        <p:spPr>
          <a:xfrm>
            <a:off x="6337582" y="1118227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6" name="TextBox 25"/>
          <p:cNvSpPr txBox="1"/>
          <p:nvPr/>
        </p:nvSpPr>
        <p:spPr>
          <a:xfrm>
            <a:off x="6365244" y="401493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7" name="TextBox 26"/>
          <p:cNvSpPr txBox="1"/>
          <p:nvPr/>
        </p:nvSpPr>
        <p:spPr>
          <a:xfrm>
            <a:off x="9915185" y="4026876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  <p:sp>
        <p:nvSpPr>
          <p:cNvPr id="28" name="TextBox 27"/>
          <p:cNvSpPr txBox="1"/>
          <p:nvPr/>
        </p:nvSpPr>
        <p:spPr>
          <a:xfrm>
            <a:off x="9904482" y="1182491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n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2400493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</TotalTime>
  <Words>601</Words>
  <Application>Microsoft Office PowerPoint</Application>
  <PresentationFormat>Widescreen</PresentationFormat>
  <Paragraphs>204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Chagne</dc:creator>
  <cp:lastModifiedBy>David Chagne</cp:lastModifiedBy>
  <cp:revision>72</cp:revision>
  <dcterms:created xsi:type="dcterms:W3CDTF">2017-10-13T01:14:03Z</dcterms:created>
  <dcterms:modified xsi:type="dcterms:W3CDTF">2018-11-02T01:42:29Z</dcterms:modified>
</cp:coreProperties>
</file>